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62" r:id="rId2"/>
    <p:sldId id="263" r:id="rId3"/>
    <p:sldId id="264" r:id="rId4"/>
    <p:sldId id="269" r:id="rId5"/>
    <p:sldId id="260" r:id="rId6"/>
    <p:sldId id="258" r:id="rId7"/>
    <p:sldId id="259" r:id="rId8"/>
  </p:sldIdLst>
  <p:sldSz cx="29879925" cy="40319325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56">
          <p15:clr>
            <a:srgbClr val="A4A3A4"/>
          </p15:clr>
        </p15:guide>
        <p15:guide id="2" pos="941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u" initials="x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14" d="100"/>
          <a:sy n="14" d="100"/>
        </p:scale>
        <p:origin x="2726" y="144"/>
      </p:cViewPr>
      <p:guideLst>
        <p:guide orient="horz" pos="12656"/>
        <p:guide pos="941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2846" y="1279525"/>
            <a:ext cx="255995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3735000" y="7778044"/>
            <a:ext cx="22410000" cy="12857959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19605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添加标题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3735000" y="21177336"/>
            <a:ext cx="22410000" cy="9734664"/>
          </a:xfrm>
        </p:spPr>
        <p:txBody>
          <a:bodyPr>
            <a:normAutofit/>
          </a:bodyPr>
          <a:lstStyle>
            <a:lvl1pPr marL="0" indent="0" algn="ctr">
              <a:buNone/>
              <a:defRPr sz="588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1494155" indent="0" algn="ctr">
              <a:buNone/>
              <a:defRPr sz="6535"/>
            </a:lvl2pPr>
            <a:lvl3pPr marL="2988310" indent="0" algn="ctr">
              <a:buNone/>
              <a:defRPr sz="5880"/>
            </a:lvl3pPr>
            <a:lvl4pPr marL="4481830" indent="0" algn="ctr">
              <a:buNone/>
              <a:defRPr sz="5230"/>
            </a:lvl4pPr>
            <a:lvl5pPr marL="5975985" indent="0" algn="ctr">
              <a:buNone/>
              <a:defRPr sz="5230"/>
            </a:lvl5pPr>
            <a:lvl6pPr marL="7470140" indent="0" algn="ctr">
              <a:buNone/>
              <a:defRPr sz="5230"/>
            </a:lvl6pPr>
            <a:lvl7pPr marL="8964295" indent="0" algn="ctr">
              <a:buNone/>
              <a:defRPr sz="5230"/>
            </a:lvl7pPr>
            <a:lvl8pPr marL="10457815" indent="0" algn="ctr">
              <a:buNone/>
              <a:defRPr sz="5230"/>
            </a:lvl8pPr>
            <a:lvl9pPr marL="11951970" indent="0" algn="ctr">
              <a:buNone/>
              <a:defRPr sz="5230"/>
            </a:lvl9pPr>
          </a:lstStyle>
          <a:p>
            <a:r>
              <a:rPr lang="zh-CN" altLang="en-US" dirty="0"/>
              <a:t>单击此处添加副标题</a:t>
            </a: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2054250" y="3242667"/>
            <a:ext cx="25771499" cy="3268266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87375" y="1519467"/>
            <a:ext cx="25771499" cy="7793336"/>
          </a:xfrm>
        </p:spPr>
        <p:txBody>
          <a:bodyPr anchor="ctr" anchorCtr="0">
            <a:normAutofit/>
          </a:bodyPr>
          <a:lstStyle>
            <a:lvl1pPr>
              <a:defRPr sz="7845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1587375" y="10733333"/>
            <a:ext cx="25771499" cy="25582669"/>
          </a:xfrm>
        </p:spPr>
        <p:txBody>
          <a:bodyPr>
            <a:normAutofit/>
          </a:bodyPr>
          <a:lstStyle>
            <a:lvl1pPr>
              <a:defRPr sz="653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588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038687" y="22053811"/>
            <a:ext cx="17943562" cy="4770183"/>
          </a:xfrm>
        </p:spPr>
        <p:txBody>
          <a:bodyPr anchor="b">
            <a:normAutofit/>
          </a:bodyPr>
          <a:lstStyle>
            <a:lvl1pPr>
              <a:defRPr sz="1307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038687" y="27103576"/>
            <a:ext cx="17943562" cy="3807147"/>
          </a:xfrm>
        </p:spPr>
        <p:txBody>
          <a:bodyPr>
            <a:normAutofit/>
          </a:bodyPr>
          <a:lstStyle>
            <a:lvl1pPr marL="0" indent="0">
              <a:buNone/>
              <a:defRPr sz="5880">
                <a:solidFill>
                  <a:schemeClr val="tx1"/>
                </a:solidFill>
              </a:defRPr>
            </a:lvl1pPr>
            <a:lvl2pPr marL="1494155" indent="0">
              <a:buNone/>
              <a:defRPr sz="6535">
                <a:solidFill>
                  <a:schemeClr val="tx1">
                    <a:tint val="75000"/>
                  </a:schemeClr>
                </a:solidFill>
              </a:defRPr>
            </a:lvl2pPr>
            <a:lvl3pPr marL="2988310" indent="0">
              <a:buNone/>
              <a:defRPr sz="5880">
                <a:solidFill>
                  <a:schemeClr val="tx1">
                    <a:tint val="75000"/>
                  </a:schemeClr>
                </a:solidFill>
              </a:defRPr>
            </a:lvl3pPr>
            <a:lvl4pPr marL="4481830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4pPr>
            <a:lvl5pPr marL="5975985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5pPr>
            <a:lvl6pPr marL="7470140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6pPr>
            <a:lvl7pPr marL="8964295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7pPr>
            <a:lvl8pPr marL="10457815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8pPr>
            <a:lvl9pPr marL="11951970" indent="0">
              <a:buNone/>
              <a:defRPr sz="52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87375" y="1519467"/>
            <a:ext cx="25771499" cy="7793336"/>
          </a:xfrm>
        </p:spPr>
        <p:txBody>
          <a:bodyPr>
            <a:normAutofit/>
          </a:bodyPr>
          <a:lstStyle>
            <a:lvl1pPr>
              <a:defRPr sz="7845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1587375" y="10733333"/>
            <a:ext cx="12699000" cy="25582669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653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588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4659875" y="10733333"/>
            <a:ext cx="12699000" cy="25582669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653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588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523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058142" y="2146667"/>
            <a:ext cx="25771499" cy="779333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058142" y="10259088"/>
            <a:ext cx="12640639" cy="4843997"/>
          </a:xfrm>
        </p:spPr>
        <p:txBody>
          <a:bodyPr anchor="b"/>
          <a:lstStyle>
            <a:lvl1pPr marL="0" indent="0">
              <a:buNone/>
              <a:defRPr sz="7845" b="1"/>
            </a:lvl1pPr>
            <a:lvl2pPr marL="1494155" indent="0">
              <a:buNone/>
              <a:defRPr sz="6535" b="1"/>
            </a:lvl2pPr>
            <a:lvl3pPr marL="2988310" indent="0">
              <a:buNone/>
              <a:defRPr sz="5880" b="1"/>
            </a:lvl3pPr>
            <a:lvl4pPr marL="4481830" indent="0">
              <a:buNone/>
              <a:defRPr sz="5230" b="1"/>
            </a:lvl4pPr>
            <a:lvl5pPr marL="5975985" indent="0">
              <a:buNone/>
              <a:defRPr sz="5230" b="1"/>
            </a:lvl5pPr>
            <a:lvl6pPr marL="7470140" indent="0">
              <a:buNone/>
              <a:defRPr sz="5230" b="1"/>
            </a:lvl6pPr>
            <a:lvl7pPr marL="8964295" indent="0">
              <a:buNone/>
              <a:defRPr sz="5230" b="1"/>
            </a:lvl7pPr>
            <a:lvl8pPr marL="10457815" indent="0">
              <a:buNone/>
              <a:defRPr sz="5230" b="1"/>
            </a:lvl8pPr>
            <a:lvl9pPr marL="11951970" indent="0">
              <a:buNone/>
              <a:defRPr sz="523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058142" y="15377859"/>
            <a:ext cx="12640639" cy="2101281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15126750" y="10259088"/>
            <a:ext cx="12702892" cy="4843997"/>
          </a:xfrm>
        </p:spPr>
        <p:txBody>
          <a:bodyPr anchor="b"/>
          <a:lstStyle>
            <a:lvl1pPr marL="0" indent="0">
              <a:buNone/>
              <a:defRPr sz="7845" b="1"/>
            </a:lvl1pPr>
            <a:lvl2pPr marL="1494155" indent="0">
              <a:buNone/>
              <a:defRPr sz="6535" b="1"/>
            </a:lvl2pPr>
            <a:lvl3pPr marL="2988310" indent="0">
              <a:buNone/>
              <a:defRPr sz="5880" b="1"/>
            </a:lvl3pPr>
            <a:lvl4pPr marL="4481830" indent="0">
              <a:buNone/>
              <a:defRPr sz="5230" b="1"/>
            </a:lvl4pPr>
            <a:lvl5pPr marL="5975985" indent="0">
              <a:buNone/>
              <a:defRPr sz="5230" b="1"/>
            </a:lvl5pPr>
            <a:lvl6pPr marL="7470140" indent="0">
              <a:buNone/>
              <a:defRPr sz="5230" b="1"/>
            </a:lvl6pPr>
            <a:lvl7pPr marL="8964295" indent="0">
              <a:buNone/>
              <a:defRPr sz="5230" b="1"/>
            </a:lvl7pPr>
            <a:lvl8pPr marL="10457815" indent="0">
              <a:buNone/>
              <a:defRPr sz="5230" b="1"/>
            </a:lvl8pPr>
            <a:lvl9pPr marL="11951970" indent="0">
              <a:buNone/>
              <a:defRPr sz="523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15126750" y="15377859"/>
            <a:ext cx="12702892" cy="2101281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054250" y="16263335"/>
            <a:ext cx="25771499" cy="7793336"/>
          </a:xfrm>
        </p:spPr>
        <p:txBody>
          <a:bodyPr>
            <a:normAutofit/>
          </a:bodyPr>
          <a:lstStyle>
            <a:lvl1pPr algn="ctr">
              <a:defRPr sz="15685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1585039" y="746667"/>
            <a:ext cx="10208019" cy="9408000"/>
          </a:xfrm>
        </p:spPr>
        <p:txBody>
          <a:bodyPr anchor="ctr" anchorCtr="0">
            <a:normAutofit/>
          </a:bodyPr>
          <a:lstStyle>
            <a:lvl1pPr>
              <a:defRPr sz="7845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12704882" y="4505598"/>
            <a:ext cx="14257149" cy="29951598"/>
          </a:xfrm>
        </p:spPr>
        <p:txBody>
          <a:bodyPr/>
          <a:lstStyle>
            <a:lvl1pPr marL="0" indent="0">
              <a:buNone/>
              <a:defRPr sz="10455"/>
            </a:lvl1pPr>
            <a:lvl2pPr marL="1494155" indent="0">
              <a:buNone/>
              <a:defRPr sz="9150"/>
            </a:lvl2pPr>
            <a:lvl3pPr marL="2988310" indent="0">
              <a:buNone/>
              <a:defRPr sz="7845"/>
            </a:lvl3pPr>
            <a:lvl4pPr marL="4481830" indent="0">
              <a:buNone/>
              <a:defRPr sz="6535"/>
            </a:lvl4pPr>
            <a:lvl5pPr marL="5975985" indent="0">
              <a:buNone/>
              <a:defRPr sz="6535"/>
            </a:lvl5pPr>
            <a:lvl6pPr marL="7470140" indent="0">
              <a:buNone/>
              <a:defRPr sz="6535"/>
            </a:lvl6pPr>
            <a:lvl7pPr marL="8964295" indent="0">
              <a:buNone/>
              <a:defRPr sz="6535"/>
            </a:lvl7pPr>
            <a:lvl8pPr marL="10457815" indent="0">
              <a:buNone/>
              <a:defRPr sz="6535"/>
            </a:lvl8pPr>
            <a:lvl9pPr marL="11951970" indent="0">
              <a:buNone/>
              <a:defRPr sz="6535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597489" y="12096000"/>
            <a:ext cx="10208019" cy="22409336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5230"/>
            </a:lvl1pPr>
            <a:lvl2pPr marL="1494155" indent="0">
              <a:buNone/>
              <a:defRPr sz="4575"/>
            </a:lvl2pPr>
            <a:lvl3pPr marL="2988310" indent="0">
              <a:buNone/>
              <a:defRPr sz="3920"/>
            </a:lvl3pPr>
            <a:lvl4pPr marL="4481830" indent="0">
              <a:buNone/>
              <a:defRPr sz="3270"/>
            </a:lvl4pPr>
            <a:lvl5pPr marL="5975985" indent="0">
              <a:buNone/>
              <a:defRPr sz="3270"/>
            </a:lvl5pPr>
            <a:lvl6pPr marL="7470140" indent="0">
              <a:buNone/>
              <a:defRPr sz="3270"/>
            </a:lvl6pPr>
            <a:lvl7pPr marL="8964295" indent="0">
              <a:buNone/>
              <a:defRPr sz="3270"/>
            </a:lvl7pPr>
            <a:lvl8pPr marL="10457815" indent="0">
              <a:buNone/>
              <a:defRPr sz="3270"/>
            </a:lvl8pPr>
            <a:lvl9pPr marL="11951970" indent="0">
              <a:buNone/>
              <a:defRPr sz="327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4/6/24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24077721" y="2146667"/>
            <a:ext cx="3748028" cy="34169336"/>
          </a:xfrm>
        </p:spPr>
        <p:txBody>
          <a:bodyPr vert="eaVert">
            <a:normAutofit/>
          </a:bodyPr>
          <a:lstStyle>
            <a:lvl1pPr>
              <a:defRPr sz="1176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054250" y="2146667"/>
            <a:ext cx="21762889" cy="34169336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2054250" y="2146667"/>
            <a:ext cx="25771499" cy="7793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054250" y="10733333"/>
            <a:ext cx="25771499" cy="255826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2054250" y="37370666"/>
            <a:ext cx="6723000" cy="21466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4/6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9897750" y="37370666"/>
            <a:ext cx="10084500" cy="21466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21102750" y="37370666"/>
            <a:ext cx="6723000" cy="21466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2988310" rtl="0" eaLnBrk="1" latinLnBrk="0" hangingPunct="1">
        <a:lnSpc>
          <a:spcPct val="90000"/>
        </a:lnSpc>
        <a:spcBef>
          <a:spcPct val="0"/>
        </a:spcBef>
        <a:buNone/>
        <a:defRPr sz="130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46760" indent="-746760" algn="l" defTabSz="2988310" rtl="0" eaLnBrk="1" latinLnBrk="0" hangingPunct="1">
        <a:lnSpc>
          <a:spcPct val="90000"/>
        </a:lnSpc>
        <a:spcBef>
          <a:spcPct val="655000"/>
        </a:spcBef>
        <a:buFont typeface="Arial" panose="02080604020202020204" pitchFamily="34" charset="0"/>
        <a:buChar char="•"/>
        <a:defRPr sz="7845" kern="1200">
          <a:solidFill>
            <a:schemeClr val="tx1"/>
          </a:solidFill>
          <a:latin typeface="+mn-lt"/>
          <a:ea typeface="+mn-ea"/>
          <a:cs typeface="+mn-cs"/>
        </a:defRPr>
      </a:lvl1pPr>
      <a:lvl2pPr marL="2240915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6535" kern="1200">
          <a:solidFill>
            <a:schemeClr val="tx1"/>
          </a:solidFill>
          <a:latin typeface="+mn-lt"/>
          <a:ea typeface="+mn-ea"/>
          <a:cs typeface="+mn-cs"/>
        </a:defRPr>
      </a:lvl2pPr>
      <a:lvl3pPr marL="3735070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3pPr>
      <a:lvl4pPr marL="5229225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4pPr>
      <a:lvl5pPr marL="6722745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5pPr>
      <a:lvl6pPr marL="8216900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6pPr>
      <a:lvl7pPr marL="9711055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7pPr>
      <a:lvl8pPr marL="11205210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8pPr>
      <a:lvl9pPr marL="12698730" indent="-746760" algn="l" defTabSz="2988310" rtl="0" eaLnBrk="1" latinLnBrk="0" hangingPunct="1">
        <a:lnSpc>
          <a:spcPct val="90000"/>
        </a:lnSpc>
        <a:spcBef>
          <a:spcPts val="1640"/>
        </a:spcBef>
        <a:buFont typeface="Arial" panose="0208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1pPr>
      <a:lvl2pPr marL="1494155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2pPr>
      <a:lvl3pPr marL="2988310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3pPr>
      <a:lvl4pPr marL="4481830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4pPr>
      <a:lvl5pPr marL="5975985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5pPr>
      <a:lvl6pPr marL="7470140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6pPr>
      <a:lvl7pPr marL="8964295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7pPr>
      <a:lvl8pPr marL="10457815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8pPr>
      <a:lvl9pPr marL="11951970" algn="l" defTabSz="298831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321945" y="3632835"/>
          <a:ext cx="29236670" cy="2760599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074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899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015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376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7699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13004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8684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FFFFFF"/>
                          </a:solidFill>
                          <a:latin typeface="Calibri" charset="0"/>
                          <a:cs typeface="宋体" charset="0"/>
                        </a:rPr>
                        <a:t>GEO accession</a:t>
                      </a:r>
                      <a:endParaRPr lang="en-US" altLang="en-US" sz="5400" b="1">
                        <a:solidFill>
                          <a:srgbClr val="FFFFFF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FFFFFF"/>
                          </a:solidFill>
                          <a:latin typeface="Calibri" charset="0"/>
                          <a:cs typeface="宋体" charset="0"/>
                        </a:rPr>
                        <a:t>Title</a:t>
                      </a:r>
                      <a:endParaRPr lang="en-US" altLang="en-US" sz="5400" b="1">
                        <a:solidFill>
                          <a:srgbClr val="FFFFFF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FFFFFF"/>
                          </a:solidFill>
                          <a:latin typeface="Calibri" charset="0"/>
                          <a:cs typeface="宋体" charset="0"/>
                        </a:rPr>
                        <a:t>gender</a:t>
                      </a:r>
                      <a:endParaRPr lang="en-US" altLang="en-US" sz="5400" b="1">
                        <a:solidFill>
                          <a:srgbClr val="FFFFFF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FFFFFF"/>
                          </a:solidFill>
                          <a:latin typeface="Calibri" charset="0"/>
                          <a:cs typeface="宋体" charset="0"/>
                        </a:rPr>
                        <a:t>tissue</a:t>
                      </a:r>
                      <a:endParaRPr lang="en-US" altLang="en-US" sz="5400" b="1">
                        <a:solidFill>
                          <a:srgbClr val="FFFFFF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FFFFFF"/>
                          </a:solidFill>
                          <a:latin typeface="Calibri" charset="0"/>
                          <a:cs typeface="宋体" charset="0"/>
                        </a:rPr>
                        <a:t>individual</a:t>
                      </a:r>
                      <a:endParaRPr lang="en-US" altLang="en-US" sz="5400" b="1">
                        <a:solidFill>
                          <a:srgbClr val="FFFFFF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63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2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1885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71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0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69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2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2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1885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70y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0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7952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3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2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1885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BenignAdjacent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769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2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1970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69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0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769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29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19703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BenignAdjacent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776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0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125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65y Fe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BenignAdjacent Cortex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1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78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1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125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BenignAdjacent Medulla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78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2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1561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43y Fe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h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1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95922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9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3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1569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76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1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763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0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156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BenignAdjacent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7952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1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260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74y 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22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769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2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260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BenignAdjacent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7762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3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81973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1_23459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66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SS_2023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8557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63002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Patient 1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43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p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8684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5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63002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Patient 2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50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cRCC 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843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4630030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Patient 4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33y Mal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chRCC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8493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5225906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s200929N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55y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kidney, Normaltissu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FD5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8684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18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GSM5225907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s200930N9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42y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000000"/>
                          </a:solidFill>
                          <a:latin typeface="Calibri" charset="0"/>
                          <a:cs typeface="宋体" charset="0"/>
                        </a:rPr>
                        <a:t> kidney, Normaltissue</a:t>
                      </a:r>
                      <a:endParaRPr lang="en-US" altLang="en-US" sz="5400" b="0">
                        <a:solidFill>
                          <a:srgbClr val="000000"/>
                        </a:solidFill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6000" b="0">
                          <a:latin typeface="Calibri" charset="0"/>
                          <a:cs typeface="宋体" charset="0"/>
                        </a:rPr>
                        <a:t> </a:t>
                      </a:r>
                      <a:endParaRPr lang="en-US" altLang="en-US" sz="6000" b="0">
                        <a:latin typeface="Calibri" charset="0"/>
                        <a:ea typeface="宋体" charset="0"/>
                        <a:cs typeface="宋体" charset="0"/>
                      </a:endParaRPr>
                    </a:p>
                  </a:txBody>
                  <a:tcPr marL="12700" marR="12700" marT="12700" anchor="ctr">
                    <a:lnL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L>
                    <a:lnR w="12700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R>
                    <a:lnT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T>
                    <a:lnB w="28575" cap="flat" cmpd="sng">
                      <a:solidFill>
                        <a:srgbClr val="FFFFFF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741044" y="1936750"/>
            <a:ext cx="17604105" cy="120032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marL="0" indent="0" algn="l"/>
            <a:r>
              <a:rPr lang="en-US" sz="7200" b="1">
                <a:latin typeface="微软雅黑" charset="0"/>
                <a:cs typeface="宋体" charset="0"/>
              </a:rPr>
              <a:t>1. Table1:Sample ID and details</a:t>
            </a:r>
            <a:endParaRPr lang="en-US" altLang="en-US" sz="7200" b="1">
              <a:latin typeface="微软雅黑" charset="0"/>
              <a:cs typeface="宋体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1696085" y="2246630"/>
            <a:ext cx="19930745" cy="230695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7200" b="1">
                <a:latin typeface="微软雅黑" charset="0"/>
                <a:cs typeface="宋体" charset="0"/>
              </a:rPr>
              <a:t>2. Table2:Cell Number of macrophage subsets in different samples</a:t>
            </a:r>
            <a:endParaRPr lang="en-US" altLang="en-US" sz="7200" b="1">
              <a:latin typeface="微软雅黑" charset="0"/>
              <a:cs typeface="宋体" charset="0"/>
            </a:endParaRPr>
          </a:p>
        </p:txBody>
      </p:sp>
      <p:graphicFrame>
        <p:nvGraphicFramePr>
          <p:cNvPr id="4" name="表格 3"/>
          <p:cNvGraphicFramePr/>
          <p:nvPr/>
        </p:nvGraphicFramePr>
        <p:xfrm>
          <a:off x="1696085" y="5408295"/>
          <a:ext cx="24383365" cy="770572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029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037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884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2882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1532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 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TAM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M2 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M1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168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c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479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491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083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8625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h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6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436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16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5450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p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208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72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51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1696085" y="14492605"/>
            <a:ext cx="20321270" cy="230695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7200" b="1">
                <a:latin typeface="微软雅黑" charset="0"/>
                <a:cs typeface="宋体" charset="0"/>
              </a:rPr>
              <a:t>3. Table3:Cell Number of CAF subsets in different samples</a:t>
            </a:r>
            <a:endParaRPr lang="en-US" altLang="en-US" sz="7200" b="1">
              <a:latin typeface="微软雅黑" charset="0"/>
              <a:cs typeface="宋体" charset="0"/>
            </a:endParaRPr>
          </a:p>
        </p:txBody>
      </p:sp>
      <p:graphicFrame>
        <p:nvGraphicFramePr>
          <p:cNvPr id="6" name="表格 5"/>
          <p:cNvGraphicFramePr/>
          <p:nvPr/>
        </p:nvGraphicFramePr>
        <p:xfrm>
          <a:off x="1696085" y="17327880"/>
          <a:ext cx="24275415" cy="131705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835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490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375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375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34581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6517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11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0728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3241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 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1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2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3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4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5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6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1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07</a:t>
                      </a:r>
                      <a:endParaRPr lang="en-US" altLang="en-US" sz="5400" b="1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7413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c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27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719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2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78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75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1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735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ch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4867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9880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pRCC 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3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742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400" b="0">
                          <a:solidFill>
                            <a:srgbClr val="2F75B5"/>
                          </a:solidFill>
                          <a:latin typeface="宋体" charset="0"/>
                          <a:cs typeface="宋体" charset="0"/>
                        </a:rPr>
                        <a:t>0</a:t>
                      </a:r>
                      <a:endParaRPr lang="en-US" altLang="en-US" sz="5400" b="0">
                        <a:solidFill>
                          <a:srgbClr val="2F75B5"/>
                        </a:solidFill>
                        <a:latin typeface="宋体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5B9BD5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781685" y="733425"/>
            <a:ext cx="15045690" cy="11988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7200" b="1">
                <a:latin typeface="微软雅黑" charset="0"/>
                <a:cs typeface="宋体" charset="0"/>
              </a:rPr>
              <a:t>4.Table4:</a:t>
            </a:r>
            <a:r>
              <a:rPr lang="en-US" sz="7200" b="1">
                <a:solidFill>
                  <a:srgbClr val="000000"/>
                </a:solidFill>
                <a:latin typeface="Times New Roman" charset="0"/>
                <a:cs typeface="等线" charset="0"/>
              </a:rPr>
              <a:t>Analysis Software</a:t>
            </a:r>
            <a:endParaRPr lang="en-US" altLang="en-US" sz="7200" b="1">
              <a:solidFill>
                <a:srgbClr val="000000"/>
              </a:solidFill>
              <a:latin typeface="Times New Roman" charset="0"/>
              <a:cs typeface="等线" charset="0"/>
            </a:endParaRPr>
          </a:p>
        </p:txBody>
      </p:sp>
      <p:graphicFrame>
        <p:nvGraphicFramePr>
          <p:cNvPr id="4" name="表格 3"/>
          <p:cNvGraphicFramePr/>
          <p:nvPr/>
        </p:nvGraphicFramePr>
        <p:xfrm>
          <a:off x="1238250" y="3040380"/>
          <a:ext cx="16242030" cy="3625217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3689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731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08175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1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</a:rPr>
                        <a:t>Software/Package</a:t>
                      </a:r>
                      <a:endParaRPr lang="en-US" altLang="en-US" sz="7200" b="1">
                        <a:solidFill>
                          <a:srgbClr val="000000"/>
                        </a:solidFill>
                        <a:latin typeface="Times New Roman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1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</a:rPr>
                        <a:t>Version</a:t>
                      </a:r>
                      <a:endParaRPr lang="en-US" altLang="en-US" sz="7200" b="1">
                        <a:solidFill>
                          <a:srgbClr val="000000"/>
                        </a:solidFill>
                        <a:latin typeface="Times New Roman" charset="0"/>
                        <a:ea typeface="等线" charset="0"/>
                        <a:cs typeface="等线" charset="0"/>
                      </a:endParaRPr>
                    </a:p>
                  </a:txBody>
                  <a:tcPr marL="68580" marR="68580" marT="0" marB="0" anchor="b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R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4.1.2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Seurat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4.0.5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ggplot2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3.3.5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dplyr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0.7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tidyverse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3.1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patchwork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1.1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harmony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0.1.0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SingleR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8.0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ellChat 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6.1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Pheatmap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0.12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pyscenic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3.1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REdaS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0.9.4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monocle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2.28.0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ytoTRACE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0.3.3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irclize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0.4.14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ReactomeGSA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12.0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lusterProfiler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4.6.2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enrichplot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72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1.18.3</a:t>
                      </a:r>
                      <a:endParaRPr lang="en-US" altLang="en-US" sz="72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781685" y="733425"/>
            <a:ext cx="15045690" cy="11988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7200" b="1">
                <a:latin typeface="微软雅黑" charset="0"/>
                <a:cs typeface="宋体" charset="0"/>
              </a:rPr>
              <a:t>5.Table5:</a:t>
            </a:r>
            <a:r>
              <a:rPr lang="en-US" sz="7200" b="1">
                <a:solidFill>
                  <a:srgbClr val="000000"/>
                </a:solidFill>
                <a:latin typeface="Times New Roman" charset="0"/>
                <a:cs typeface="等线" charset="0"/>
              </a:rPr>
              <a:t>The abbreviations used </a:t>
            </a:r>
          </a:p>
        </p:txBody>
      </p:sp>
      <p:graphicFrame>
        <p:nvGraphicFramePr>
          <p:cNvPr id="4" name="表格 3"/>
          <p:cNvGraphicFramePr/>
          <p:nvPr/>
        </p:nvGraphicFramePr>
        <p:xfrm>
          <a:off x="1238250" y="3040380"/>
          <a:ext cx="25361265" cy="27320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3689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923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08175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</a:rPr>
                        <a:t>RCC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</a:rPr>
                        <a:t>Renal cell carcinoma</a:t>
                      </a:r>
                    </a:p>
                  </a:txBody>
                  <a:tcPr marL="68580" marR="68580" marT="0" marB="0" anchor="b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UMAP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Uniform Manifold Approximation and Projection 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754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AFs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ancer-associated fibroblasts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GO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gene ontology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8175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BP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biological process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CC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cell component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MF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molecular function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altLang="en-US" sz="6600" b="0">
                          <a:solidFill>
                            <a:srgbClr val="000000"/>
                          </a:solidFill>
                          <a:latin typeface="Palatino Linotype" charset="0"/>
                          <a:ea typeface="宋体" charset="0"/>
                          <a:cs typeface="宋体" charset="0"/>
                        </a:rPr>
                        <a:t>TAMs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Tumor-associated macrophages 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TME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Tumor micro-environment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altLang="en-US" sz="6600" b="0">
                          <a:solidFill>
                            <a:srgbClr val="000000"/>
                          </a:solidFill>
                          <a:latin typeface="Palatino Linotype" charset="0"/>
                          <a:ea typeface="宋体" charset="0"/>
                          <a:cs typeface="宋体" charset="0"/>
                        </a:rPr>
                        <a:t>MT+ T cell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T Cells with high expression of genes beginning with MT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cRC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lear cell </a:t>
                      </a:r>
                      <a:r>
                        <a:rPr lang="en-US" sz="6600" b="0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  <a:sym typeface="+mn-ea"/>
                        </a:rPr>
                        <a:t>Renal cell carcinoma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chRC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  <a:sym typeface="+mn-ea"/>
                        </a:rPr>
                        <a:t>chromophobe Renal cell carcinoma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Times New Roman" charset="0"/>
                        <a:ea typeface="宋体" charset="0"/>
                        <a:cs typeface="等线" charset="0"/>
                        <a:sym typeface="+mn-ea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pRC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Times New Roman" charset="0"/>
                          <a:cs typeface="等线" charset="0"/>
                          <a:sym typeface="+mn-ea"/>
                        </a:rPr>
                        <a:t>papillary Renal cell carcinoma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Times New Roman" charset="0"/>
                        <a:ea typeface="宋体" charset="0"/>
                        <a:cs typeface="等线" charset="0"/>
                        <a:sym typeface="+mn-ea"/>
                      </a:endParaRP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08000"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  <a:sym typeface="+mn-ea"/>
                        </a:rPr>
                        <a:t>ReactomeGSA</a:t>
                      </a:r>
                      <a:endParaRPr lang="en-US" altLang="en-US" sz="6600" b="0">
                        <a:solidFill>
                          <a:srgbClr val="000000"/>
                        </a:solidFill>
                        <a:latin typeface="Palatino Linotype" charset="0"/>
                        <a:ea typeface="宋体" charset="0"/>
                        <a:cs typeface="宋体" charset="0"/>
                        <a:sym typeface="+mn-ea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10000"/>
                        </a:lnSpc>
                        <a:buNone/>
                      </a:pPr>
                      <a:r>
                        <a:rPr lang="en-US" sz="6600" b="0">
                          <a:solidFill>
                            <a:srgbClr val="000000"/>
                          </a:solidFill>
                          <a:latin typeface="Palatino Linotype" charset="0"/>
                          <a:cs typeface="宋体" charset="0"/>
                        </a:rPr>
                        <a:t>Reactome Gene Set Variation Analysis </a:t>
                      </a:r>
                    </a:p>
                  </a:txBody>
                  <a:tcPr marL="68580" marR="68580" marT="0" marB="0" anchor="ctr">
                    <a:lnL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652780" y="1459230"/>
            <a:ext cx="26227405" cy="277920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marL="0" indent="0"/>
            <a:r>
              <a:rPr lang="en-US" sz="7200" b="1">
                <a:solidFill>
                  <a:srgbClr val="000000"/>
                </a:solidFill>
                <a:sym typeface="+mn-ea"/>
              </a:rPr>
              <a:t>6.Supplement Figure 1:</a:t>
            </a:r>
            <a:r>
              <a:rPr lang="en-US" sz="7200" b="1">
                <a:solidFill>
                  <a:srgbClr val="000000"/>
                </a:solidFill>
              </a:rPr>
              <a:t>The T-cell landscape of renal cell carcinoma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A) Dimensional reducing and clustering on the data for T cell  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B)Add annotation for T cell clustering results.  Tcm, central memory; Tem, effector memory; Tm,memory;Teff, effector ;MT+ T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C) Dot plot of Top2 Marker in 5 T cell subtypes (by origion)</a:t>
            </a:r>
          </a:p>
          <a:p>
            <a:pPr marL="0" indent="0"/>
            <a:r>
              <a:rPr lang="en-US" sz="7200">
                <a:solidFill>
                  <a:srgbClr val="000000"/>
                </a:solidFill>
                <a:sym typeface="+mn-ea"/>
              </a:rPr>
              <a:t>D) The Dot plot shows the expression of Top5 Marker across 9 T cell clusters  </a:t>
            </a:r>
            <a:endParaRPr lang="en-US" sz="7200" b="0">
              <a:solidFill>
                <a:srgbClr val="000000"/>
              </a:solidFill>
              <a:sym typeface="+mn-ea"/>
            </a:endParaRP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E) Fractional changes for each T cell subtype across the Tumor and Benign adjacent sample. Error bars indicate the 95% confidence interval for the calculated relative frequencies. ∗p &lt; 0.01 using a chi-square test of independence.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F) Fractional changes for each T cell subtype across the three Tumor subtypes. Error bars indicate the 95% confidence interval for the calculated relative frequencies. ∗p &lt; 0.01 using a chi-square test of independence.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G) Heatmap of normalized T cell marker expression for 8 T cell clusters from tumor sample. </a:t>
            </a:r>
          </a:p>
          <a:p>
            <a:pPr marL="0" indent="0"/>
            <a:r>
              <a:rPr lang="en-US" sz="7200" b="0">
                <a:solidFill>
                  <a:srgbClr val="000000"/>
                </a:solidFill>
                <a:sym typeface="+mn-ea"/>
              </a:rPr>
              <a:t>H)Box plots of the expression levels of the genes in Figure G in three renal cancer types, with each box plot representing the expression level of a  gene across different renal cancer type. Kidney cancer types were marked on the horizontal axis, and gene expression levels were marked on the vertical axis. The P-value is calculated using T.TEST to check whether there are significant differences in the expression levels of the same gene in different cell types.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 descr="TRCC1-pheatmap"/>
          <p:cNvPicPr>
            <a:picLocks noChangeAspect="1"/>
          </p:cNvPicPr>
          <p:nvPr/>
        </p:nvPicPr>
        <p:blipFill>
          <a:blip r:embed="rId3"/>
          <a:srcRect l="9867" t="34228" r="13910" b="35760"/>
          <a:stretch>
            <a:fillRect/>
          </a:stretch>
        </p:blipFill>
        <p:spPr>
          <a:xfrm>
            <a:off x="11339830" y="17063720"/>
            <a:ext cx="18033365" cy="8875395"/>
          </a:xfrm>
          <a:prstGeom prst="rect">
            <a:avLst/>
          </a:prstGeom>
        </p:spPr>
      </p:pic>
      <p:pic>
        <p:nvPicPr>
          <p:cNvPr id="41" name="图片 40" descr="T_Markers_DotPlot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0425" y="9502775"/>
            <a:ext cx="10528935" cy="15796895"/>
          </a:xfrm>
          <a:prstGeom prst="rect">
            <a:avLst/>
          </a:prstGeom>
        </p:spPr>
      </p:pic>
      <p:grpSp>
        <p:nvGrpSpPr>
          <p:cNvPr id="27" name="组合 26"/>
          <p:cNvGrpSpPr>
            <a:grpSpLocks noChangeAspect="1"/>
          </p:cNvGrpSpPr>
          <p:nvPr/>
        </p:nvGrpSpPr>
        <p:grpSpPr>
          <a:xfrm>
            <a:off x="9179560" y="9809480"/>
            <a:ext cx="9792000" cy="6515330"/>
            <a:chOff x="1530" y="7274"/>
            <a:chExt cx="4331" cy="3097"/>
          </a:xfrm>
        </p:grpSpPr>
        <p:pic>
          <p:nvPicPr>
            <p:cNvPr id="7" name="图片 6" descr="T_barplot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30" y="7437"/>
              <a:ext cx="4331" cy="2934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1785" y="7274"/>
              <a:ext cx="864" cy="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ctr" hangingPunct="0">
                <a:lnSpc>
                  <a:spcPct val="90000"/>
                </a:lnSpc>
              </a:pPr>
              <a:r>
                <a:rPr lang="en-US" altLang="zh-CN" sz="2125" dirty="0"/>
                <a:t>Tcm</a:t>
              </a:r>
            </a:p>
          </p:txBody>
        </p:sp>
        <p:sp>
          <p:nvSpPr>
            <p:cNvPr id="17" name="矩形 16"/>
            <p:cNvSpPr/>
            <p:nvPr/>
          </p:nvSpPr>
          <p:spPr>
            <a:xfrm>
              <a:off x="3596" y="7278"/>
              <a:ext cx="864" cy="190"/>
            </a:xfrm>
            <a:prstGeom prst="rect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125" dirty="0"/>
                <a:t>Teff</a:t>
              </a:r>
            </a:p>
          </p:txBody>
        </p:sp>
        <p:sp>
          <p:nvSpPr>
            <p:cNvPr id="12" name="矩形 11"/>
            <p:cNvSpPr/>
            <p:nvPr/>
          </p:nvSpPr>
          <p:spPr>
            <a:xfrm>
              <a:off x="2691" y="7274"/>
              <a:ext cx="412" cy="19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indent="-1619885" fontAlgn="ctr" hangingPunct="0"/>
              <a:r>
                <a:rPr lang="en-US" altLang="zh-CN" sz="2125" dirty="0"/>
                <a:t>MT</a:t>
              </a:r>
            </a:p>
          </p:txBody>
        </p:sp>
        <p:sp>
          <p:nvSpPr>
            <p:cNvPr id="14" name="矩形 13"/>
            <p:cNvSpPr/>
            <p:nvPr/>
          </p:nvSpPr>
          <p:spPr>
            <a:xfrm>
              <a:off x="3145" y="7274"/>
              <a:ext cx="410" cy="19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2125" dirty="0">
                  <a:solidFill>
                    <a:schemeClr val="bg1"/>
                  </a:solidFill>
                </a:rPr>
                <a:t>Tem</a:t>
              </a:r>
              <a:endParaRPr lang="en-US" altLang="zh-CN" sz="2125" dirty="0">
                <a:solidFill>
                  <a:schemeClr val="bg1"/>
                </a:solidFill>
                <a:sym typeface="+mn-ea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4501" y="7274"/>
              <a:ext cx="1321" cy="19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2125" dirty="0"/>
                <a:t>Tm</a:t>
              </a:r>
            </a:p>
          </p:txBody>
        </p:sp>
      </p:grpSp>
      <p:pic>
        <p:nvPicPr>
          <p:cNvPr id="42" name="图片 41" descr="T_new_clusters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3920" y="1532255"/>
            <a:ext cx="9829165" cy="6553200"/>
          </a:xfrm>
          <a:prstGeom prst="rect">
            <a:avLst/>
          </a:prstGeom>
        </p:spPr>
      </p:pic>
      <p:grpSp>
        <p:nvGrpSpPr>
          <p:cNvPr id="28" name="组合 27"/>
          <p:cNvGrpSpPr>
            <a:grpSpLocks noChangeAspect="1"/>
          </p:cNvGrpSpPr>
          <p:nvPr/>
        </p:nvGrpSpPr>
        <p:grpSpPr>
          <a:xfrm>
            <a:off x="19980706" y="9809480"/>
            <a:ext cx="9792000" cy="6591007"/>
            <a:chOff x="6275899" y="2424344"/>
            <a:chExt cx="2834640" cy="1765790"/>
          </a:xfrm>
        </p:grpSpPr>
        <p:pic>
          <p:nvPicPr>
            <p:cNvPr id="6" name="图片 5" descr="T_barplot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275899" y="2517280"/>
              <a:ext cx="2834640" cy="1672854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>
              <a:off x="6467669" y="2424914"/>
              <a:ext cx="555625" cy="10833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2125" dirty="0" err="1"/>
                <a:t>Tcm</a:t>
              </a:r>
              <a:endParaRPr lang="en-US" altLang="zh-CN" sz="2125" dirty="0"/>
            </a:p>
          </p:txBody>
        </p:sp>
        <p:sp>
          <p:nvSpPr>
            <p:cNvPr id="9" name="矩形 8"/>
            <p:cNvSpPr/>
            <p:nvPr/>
          </p:nvSpPr>
          <p:spPr>
            <a:xfrm>
              <a:off x="7051869" y="2424914"/>
              <a:ext cx="266065" cy="108331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2125"/>
                <a:t>MT</a:t>
              </a:r>
            </a:p>
          </p:txBody>
        </p:sp>
        <p:sp>
          <p:nvSpPr>
            <p:cNvPr id="10" name="矩形 9"/>
            <p:cNvSpPr/>
            <p:nvPr/>
          </p:nvSpPr>
          <p:spPr>
            <a:xfrm>
              <a:off x="7347144" y="2424344"/>
              <a:ext cx="261620" cy="10833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en-US" altLang="zh-CN" sz="2125"/>
                <a:t>T</a:t>
              </a:r>
              <a:r>
                <a:rPr lang="en-US" altLang="zh-CN" sz="2125">
                  <a:sym typeface="+mn-ea"/>
                </a:rPr>
                <a:t>em</a:t>
              </a:r>
            </a:p>
          </p:txBody>
        </p:sp>
        <p:sp>
          <p:nvSpPr>
            <p:cNvPr id="11" name="矩形 10"/>
            <p:cNvSpPr/>
            <p:nvPr/>
          </p:nvSpPr>
          <p:spPr>
            <a:xfrm>
              <a:off x="7637974" y="2424344"/>
              <a:ext cx="561340" cy="108331"/>
            </a:xfrm>
            <a:prstGeom prst="rect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125"/>
                <a:t>Teff</a:t>
              </a:r>
            </a:p>
          </p:txBody>
        </p:sp>
        <p:sp>
          <p:nvSpPr>
            <p:cNvPr id="16" name="矩形 15"/>
            <p:cNvSpPr/>
            <p:nvPr/>
          </p:nvSpPr>
          <p:spPr>
            <a:xfrm>
              <a:off x="8229159" y="2424344"/>
              <a:ext cx="850265" cy="108331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125"/>
                <a:t>Tm</a:t>
              </a:r>
            </a:p>
          </p:txBody>
        </p:sp>
      </p:grpSp>
      <p:pic>
        <p:nvPicPr>
          <p:cNvPr id="19" name="图片 18" descr="城市里有灯光&#10;&#10;中度可信度描述已自动生成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72755" y="1151255"/>
            <a:ext cx="9051925" cy="754316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67360" y="859155"/>
            <a:ext cx="128016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A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200660" y="9142730"/>
            <a:ext cx="1854835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D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19102705" y="9142730"/>
            <a:ext cx="140970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F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10713085" y="17855565"/>
            <a:ext cx="140970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G</a:t>
            </a:r>
          </a:p>
        </p:txBody>
      </p:sp>
      <p:pic>
        <p:nvPicPr>
          <p:cNvPr id="39" name="图片 38" descr="T_CellType_arti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979785" y="1798320"/>
            <a:ext cx="9669780" cy="6447155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10564495" y="859155"/>
            <a:ext cx="774065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B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20196810" y="859155"/>
            <a:ext cx="140970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C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7853045" y="9142730"/>
            <a:ext cx="140970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E</a:t>
            </a:r>
          </a:p>
        </p:txBody>
      </p:sp>
      <p:pic>
        <p:nvPicPr>
          <p:cNvPr id="21" name="图片 20" descr="boxplotSCT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31410" y="26280745"/>
            <a:ext cx="20631150" cy="134112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202940" y="26568400"/>
            <a:ext cx="140970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H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图片 3" descr="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8760" y="16081375"/>
            <a:ext cx="9863662" cy="19800001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5318760" y="14697710"/>
            <a:ext cx="128016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A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7656810" y="7526020"/>
            <a:ext cx="1280160" cy="1383665"/>
          </a:xfrm>
          <a:prstGeom prst="rect">
            <a:avLst/>
          </a:prstGeom>
          <a:noFill/>
        </p:spPr>
        <p:txBody>
          <a:bodyPr wrap="square" rtlCol="0" anchor="t" anchorCtr="0">
            <a:spAutoFit/>
          </a:bodyPr>
          <a:lstStyle/>
          <a:p>
            <a:r>
              <a:rPr lang="en-US" altLang="zh-CN" sz="8400" dirty="0">
                <a:latin typeface="+mn-ea"/>
              </a:rPr>
              <a:t>B</a:t>
            </a:r>
          </a:p>
        </p:txBody>
      </p:sp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8936731" y="6108065"/>
            <a:ext cx="9609455" cy="10800000"/>
            <a:chOff x="14943" y="6298"/>
            <a:chExt cx="10172" cy="11432"/>
          </a:xfrm>
        </p:grpSpPr>
        <p:pic>
          <p:nvPicPr>
            <p:cNvPr id="7" name="图片 6" descr="ccrcc"/>
            <p:cNvPicPr>
              <a:picLocks noChangeAspect="1"/>
            </p:cNvPicPr>
            <p:nvPr/>
          </p:nvPicPr>
          <p:blipFill>
            <a:blip r:embed="rId3"/>
            <a:srcRect t="50841"/>
            <a:stretch>
              <a:fillRect/>
            </a:stretch>
          </p:blipFill>
          <p:spPr>
            <a:xfrm>
              <a:off x="14943" y="6298"/>
              <a:ext cx="10172" cy="9615"/>
            </a:xfrm>
            <a:prstGeom prst="rect">
              <a:avLst/>
            </a:prstGeom>
          </p:spPr>
        </p:pic>
        <p:sp>
          <p:nvSpPr>
            <p:cNvPr id="25" name="文本框 24"/>
            <p:cNvSpPr txBox="1"/>
            <p:nvPr/>
          </p:nvSpPr>
          <p:spPr>
            <a:xfrm>
              <a:off x="18272" y="16423"/>
              <a:ext cx="3514" cy="1307"/>
            </a:xfrm>
            <a:prstGeom prst="rect">
              <a:avLst/>
            </a:prstGeom>
            <a:noFill/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4800" dirty="0">
                  <a:latin typeface="+mn-ea"/>
                </a:rPr>
                <a:t>ccRCC</a:t>
              </a:r>
            </a:p>
          </p:txBody>
        </p:sp>
      </p:grpSp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19243436" y="16908065"/>
            <a:ext cx="9149080" cy="10799445"/>
            <a:chOff x="25909" y="6347"/>
            <a:chExt cx="9784" cy="11549"/>
          </a:xfrm>
        </p:grpSpPr>
        <p:pic>
          <p:nvPicPr>
            <p:cNvPr id="10" name="图片 9" descr="chrcc"/>
            <p:cNvPicPr>
              <a:picLocks noChangeAspect="1"/>
            </p:cNvPicPr>
            <p:nvPr/>
          </p:nvPicPr>
          <p:blipFill>
            <a:blip r:embed="rId4"/>
            <a:srcRect t="51092"/>
            <a:stretch>
              <a:fillRect/>
            </a:stretch>
          </p:blipFill>
          <p:spPr>
            <a:xfrm>
              <a:off x="25909" y="6347"/>
              <a:ext cx="9784" cy="9566"/>
            </a:xfrm>
            <a:prstGeom prst="rect">
              <a:avLst/>
            </a:prstGeom>
          </p:spPr>
        </p:pic>
        <p:sp>
          <p:nvSpPr>
            <p:cNvPr id="26" name="文本框 25"/>
            <p:cNvSpPr txBox="1"/>
            <p:nvPr/>
          </p:nvSpPr>
          <p:spPr>
            <a:xfrm>
              <a:off x="28624" y="16589"/>
              <a:ext cx="3514" cy="1307"/>
            </a:xfrm>
            <a:prstGeom prst="rect">
              <a:avLst/>
            </a:prstGeom>
            <a:noFill/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4800" dirty="0">
                  <a:latin typeface="+mn-ea"/>
                </a:rPr>
                <a:t>chRCC</a:t>
              </a:r>
            </a:p>
          </p:txBody>
        </p:sp>
      </p:grpSp>
      <p:grpSp>
        <p:nvGrpSpPr>
          <p:cNvPr id="6" name="组合 5"/>
          <p:cNvGrpSpPr>
            <a:grpSpLocks noChangeAspect="1"/>
          </p:cNvGrpSpPr>
          <p:nvPr/>
        </p:nvGrpSpPr>
        <p:grpSpPr>
          <a:xfrm>
            <a:off x="19241770" y="28339335"/>
            <a:ext cx="8997711" cy="10799445"/>
            <a:chOff x="37056" y="6126"/>
            <a:chExt cx="9810" cy="11775"/>
          </a:xfrm>
        </p:grpSpPr>
        <p:pic>
          <p:nvPicPr>
            <p:cNvPr id="24" name="图片 23" descr="prcc"/>
            <p:cNvPicPr>
              <a:picLocks noChangeAspect="1"/>
            </p:cNvPicPr>
            <p:nvPr/>
          </p:nvPicPr>
          <p:blipFill>
            <a:blip r:embed="rId5"/>
            <a:srcRect t="49962"/>
            <a:stretch>
              <a:fillRect/>
            </a:stretch>
          </p:blipFill>
          <p:spPr>
            <a:xfrm>
              <a:off x="37056" y="6126"/>
              <a:ext cx="9810" cy="9787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/>
          </p:nvSpPr>
          <p:spPr>
            <a:xfrm>
              <a:off x="39771" y="16594"/>
              <a:ext cx="3514" cy="1307"/>
            </a:xfrm>
            <a:prstGeom prst="rect">
              <a:avLst/>
            </a:prstGeom>
            <a:noFill/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4800" dirty="0">
                  <a:latin typeface="+mn-ea"/>
                </a:rPr>
                <a:t>pRCC</a:t>
              </a:r>
            </a:p>
          </p:txBody>
        </p:sp>
      </p:grpSp>
      <p:sp>
        <p:nvSpPr>
          <p:cNvPr id="100" name="文本框 99"/>
          <p:cNvSpPr txBox="1"/>
          <p:nvPr/>
        </p:nvSpPr>
        <p:spPr>
          <a:xfrm>
            <a:off x="381000" y="507365"/>
            <a:ext cx="16639540" cy="115404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marL="0" indent="0"/>
            <a:r>
              <a:rPr lang="en-US" sz="7200" b="1">
                <a:solidFill>
                  <a:srgbClr val="000000"/>
                </a:solidFill>
              </a:rPr>
              <a:t>7.Supplement Figure 2.Global analysis cell-cell interaction features in different renal cell carcinoma subtypes.</a:t>
            </a:r>
          </a:p>
          <a:p>
            <a:pPr marL="0" indent="0"/>
            <a:r>
              <a:rPr lang="en-US" sz="6600" b="0">
                <a:solidFill>
                  <a:srgbClr val="000000"/>
                </a:solidFill>
              </a:rPr>
              <a:t>A)  Cell-cell communication of major cell types was analyzed in all samples.</a:t>
            </a:r>
          </a:p>
          <a:p>
            <a:pPr marL="0" indent="0"/>
            <a:r>
              <a:rPr lang="en-US" sz="6600">
                <a:solidFill>
                  <a:srgbClr val="000000"/>
                </a:solidFill>
                <a:sym typeface="+mn-ea"/>
              </a:rPr>
              <a:t>B) Cell-cell communication of major cell types was analyzed in ccRCC</a:t>
            </a:r>
          </a:p>
          <a:p>
            <a:pPr marL="0" indent="0"/>
            <a:r>
              <a:rPr lang="en-US" sz="6600">
                <a:solidFill>
                  <a:srgbClr val="000000"/>
                </a:solidFill>
                <a:sym typeface="+mn-ea"/>
              </a:rPr>
              <a:t>C)Cell-cell communication of major cell types was analyzed in chRCC</a:t>
            </a:r>
          </a:p>
          <a:p>
            <a:pPr marL="0" indent="0"/>
            <a:r>
              <a:rPr lang="en-US" sz="6600">
                <a:solidFill>
                  <a:srgbClr val="000000"/>
                </a:solidFill>
                <a:sym typeface="+mn-ea"/>
              </a:rPr>
              <a:t>D)Cell-cell communication of major cell types was analyzed in pRCC</a:t>
            </a:r>
            <a:endParaRPr lang="en-US" sz="6600" b="0">
              <a:solidFill>
                <a:srgbClr val="000000"/>
              </a:solidFill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Black-Arial">
      <a:majorFont>
        <a:latin typeface="Arial Black"/>
        <a:ea typeface=""/>
        <a:cs typeface=""/>
        <a:font script="Jpan" typeface="ＭＳ ゴシック"/>
        <a:font script="Hang" typeface="굴림"/>
        <a:font script="Hans" typeface="宋体"/>
        <a:font script="Hant" typeface="新細明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3</Words>
  <Application>Microsoft Office PowerPoint</Application>
  <PresentationFormat>Custom</PresentationFormat>
  <Paragraphs>260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微软雅黑</vt:lpstr>
      <vt:lpstr>宋体</vt:lpstr>
      <vt:lpstr>Arial</vt:lpstr>
      <vt:lpstr>Arial Black</vt:lpstr>
      <vt:lpstr>Calibri</vt:lpstr>
      <vt:lpstr>Palatino Linotype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Paree, Rachel Vinitha (ELS-CHN)</cp:lastModifiedBy>
  <cp:revision>14</cp:revision>
  <dcterms:created xsi:type="dcterms:W3CDTF">2023-12-19T17:55:15Z</dcterms:created>
  <dcterms:modified xsi:type="dcterms:W3CDTF">2024-06-23T20:1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664</vt:lpwstr>
  </property>
  <property fmtid="{D5CDD505-2E9C-101B-9397-08002B2CF9AE}" pid="3" name="ICV">
    <vt:lpwstr/>
  </property>
  <property fmtid="{D5CDD505-2E9C-101B-9397-08002B2CF9AE}" pid="4" name="MSIP_Label_549ac42a-3eb4-4074-b885-aea26bd6241e_Enabled">
    <vt:lpwstr>true</vt:lpwstr>
  </property>
  <property fmtid="{D5CDD505-2E9C-101B-9397-08002B2CF9AE}" pid="5" name="MSIP_Label_549ac42a-3eb4-4074-b885-aea26bd6241e_SetDate">
    <vt:lpwstr>2024-06-23T20:16:12Z</vt:lpwstr>
  </property>
  <property fmtid="{D5CDD505-2E9C-101B-9397-08002B2CF9AE}" pid="6" name="MSIP_Label_549ac42a-3eb4-4074-b885-aea26bd6241e_Method">
    <vt:lpwstr>Standard</vt:lpwstr>
  </property>
  <property fmtid="{D5CDD505-2E9C-101B-9397-08002B2CF9AE}" pid="7" name="MSIP_Label_549ac42a-3eb4-4074-b885-aea26bd6241e_Name">
    <vt:lpwstr>General Business</vt:lpwstr>
  </property>
  <property fmtid="{D5CDD505-2E9C-101B-9397-08002B2CF9AE}" pid="8" name="MSIP_Label_549ac42a-3eb4-4074-b885-aea26bd6241e_SiteId">
    <vt:lpwstr>9274ee3f-9425-4109-a27f-9fb15c10675d</vt:lpwstr>
  </property>
  <property fmtid="{D5CDD505-2E9C-101B-9397-08002B2CF9AE}" pid="9" name="MSIP_Label_549ac42a-3eb4-4074-b885-aea26bd6241e_ActionId">
    <vt:lpwstr>69ba593d-2d6d-4e61-930e-4b9c8c291106</vt:lpwstr>
  </property>
  <property fmtid="{D5CDD505-2E9C-101B-9397-08002B2CF9AE}" pid="10" name="MSIP_Label_549ac42a-3eb4-4074-b885-aea26bd6241e_ContentBits">
    <vt:lpwstr>0</vt:lpwstr>
  </property>
</Properties>
</file>